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1" r:id="rId3"/>
    <p:sldId id="300" r:id="rId4"/>
    <p:sldId id="302" r:id="rId5"/>
    <p:sldId id="30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8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9F300-E6A0-6B70-4E95-9EBA34646D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E8F159-89B3-5B7D-C183-6734FE1745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C76AC-AAEF-5881-B1B5-A044A4EBF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CFFD1-47BA-A810-3727-D8D24DFC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CE0049-D1EF-4F71-E4A8-66F9E4B0B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122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E3CE3-E586-65CB-BAA9-7A5BAAAA86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97330A-100B-6E0A-9895-A68BFF9C9A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71435F-8D23-EE54-8625-FC699400C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A24E87-6041-433C-3C9C-14EED3BED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980EA8-545D-0F86-9699-40C5F5B09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051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69FE81-45F9-7CCE-282B-8383E61BEB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7AE6C0-F93A-1552-F5EC-49A41FA674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299BFA-2EBA-2805-2BA5-471F1070F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567E85-0500-F622-5EAD-2BF07EDE9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B6DFF7-4D9F-7EDB-8B9F-B4C3ADBBC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61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C8A792-6FAB-FC7A-9687-F091FC5F2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FD282F-EB7B-F2C1-3DA8-AB3BFB0BA0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6D03A-8ECF-B502-4900-2D6643FEC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4A82B7-2105-B631-FB4B-E23097D03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8BAE3B-E568-B60A-9D14-D00F1D864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851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2D4C3-64A1-01E5-2AB7-5BB0AA82D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B7F7D2-3DF1-1473-FCFF-5063697DD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3D5302-1C90-717A-D23F-66F84926E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3FDFC3-5FD0-3A92-E95E-019D09D88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7A4C08-E1BB-502D-CC78-37540E5A7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532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165124-0906-B817-B564-1ACA5A2075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87B9A0-1659-67F9-D2FE-AFE56862B5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1D4047-269C-5EAC-64EC-C1F8DDB598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83FE87-D34C-791C-9B6E-62903EB81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A62655-D439-B43F-2F81-067F1A56B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987273-D6C0-E78B-28C5-F122E514F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881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D8438-A9BF-E8C5-1193-314C3BD84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6A7F72-42E4-A194-B7D2-A24ED6CED6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68436C-3D4E-5F65-B64F-6A6736529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475960-9ED8-B2A5-E6BB-740F1EAFED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40508CE-FA80-5515-5A6C-6EFD44B186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3B80813-0D6F-FCB6-0D7B-A796DCC5B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04998F-FAF4-470E-8890-D9F2F48AC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18ECE3-740C-A56C-3B68-DEA394383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384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B89D7D-F40C-544F-975D-45F54E63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37957C-9D54-8A38-D02A-7AA56CBD9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F6230C-CAEC-94D1-8B96-D98265BCB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6A9C3F-5D1D-BE11-7C98-2D2C2C3CE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9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D3D817-DDE6-2B81-5C8B-B9AF3F12A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46B511-C453-8D69-E61B-9FBF5D7F7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414535-6A11-83C8-62FE-1A0C10FD0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535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26AA27-E306-5515-A514-43BD9DF6A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DBCA8C-7C5B-4A2B-AA22-DD7C8EB0EA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F30B71-29BF-7484-B592-FEC97EEF0E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4CEAF2-9945-4A38-216A-1196A8B86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759055-4279-508E-3F56-2F204FFBC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086721-DAD5-8552-A4E9-494F3F025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215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760AB0-75AE-3B22-352E-71FC0B91A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ED04A2-E787-16D3-804A-AC24B5AD4A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1EBBF3-ED17-1842-781D-C1A8024AF3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A0161D-833F-385B-FF7D-A9ED02DF3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413302-E617-9C0B-E808-1CF5155B4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C25BF-8157-576F-0B97-F37A96B18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358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2EAE53-61E5-BCFA-A3DC-0E5858E6E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6A8417-6A15-B1AB-3243-3C40508DBE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774ABB-B838-DDE2-29B2-8B50890BF8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51086D-FB5E-492F-AA25-04EE6BE75B17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7EC1AF-F075-B5EE-9FD8-82520E2A5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AC7E02-6735-89D4-83C7-63EBA944C7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B14B53-446D-46C0-845E-8A8099C63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15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0BD9D-95F7-368B-9765-893521378B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002890"/>
            <a:ext cx="9144000" cy="2507073"/>
          </a:xfrm>
        </p:spPr>
        <p:txBody>
          <a:bodyPr>
            <a:normAutofit/>
          </a:bodyPr>
          <a:lstStyle/>
          <a:p>
            <a:pPr marL="0" marR="0">
              <a:lnSpc>
                <a:spcPct val="200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erexpression of mGlu</a:t>
            </a:r>
            <a:r>
              <a:rPr lang="en-US" sz="1800" b="1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B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mice: implications for neurodevelopmental disorders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anne A. Freitas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elly Weiss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aishnavi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vadekar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heryl Anne D. Vermudez, Nicole M. Fisher, Aditi Buch, Shalini Dogra, Zixiu Xiang, Rocco G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ogliotti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olleen M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swender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FD8ECD-8A84-00B0-E205-DF662C76FC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473677"/>
            <a:ext cx="9144000" cy="692048"/>
          </a:xfrm>
        </p:spPr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nformation</a:t>
            </a:r>
          </a:p>
        </p:txBody>
      </p:sp>
    </p:spTree>
    <p:extLst>
      <p:ext uri="{BB962C8B-B14F-4D97-AF65-F5344CB8AC3E}">
        <p14:creationId xmlns:p14="http://schemas.microsoft.com/office/powerpoint/2010/main" val="3660141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3B1922-FC17-1EB4-C3AE-9ADF7D2C71C6}"/>
              </a:ext>
            </a:extLst>
          </p:cNvPr>
          <p:cNvSpPr txBox="1"/>
          <p:nvPr/>
        </p:nvSpPr>
        <p:spPr>
          <a:xfrm>
            <a:off x="241302" y="315011"/>
            <a:ext cx="11313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 Fig. 1 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DDF10750-E402-29D7-1F25-2A08AEC0FD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429" y="1517738"/>
            <a:ext cx="11693141" cy="38225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52308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F1E76F-1C3C-1681-1855-C8D5C95AF57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A756E80-1FD2-163B-DB74-CD4D4F795306}"/>
              </a:ext>
            </a:extLst>
          </p:cNvPr>
          <p:cNvSpPr txBox="1"/>
          <p:nvPr/>
        </p:nvSpPr>
        <p:spPr>
          <a:xfrm>
            <a:off x="241302" y="315011"/>
            <a:ext cx="11313674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 Fig. 1 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uman </a:t>
            </a:r>
            <a:r>
              <a:rPr lang="en-US" sz="20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M7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RNA is increased in the cortex and amygdala of </a:t>
            </a:r>
            <a:r>
              <a:rPr lang="en-US" sz="20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/+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RNA scope in-situ hybridization image showing increased expression of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M7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ON/+ mice (red) compared to +/+ mice (black) in the cortex 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B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amygdala 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, D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Inset images note the signal differences detected between groups. Red: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M7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RNA; Blue: indicates nuclei counterstain with DAPI. Scale bar: 100 µm. For 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he total mean fluorescence intensity signal, in relative fluorescence units (RFU) by area (mm</a:t>
            </a:r>
            <a:r>
              <a:rPr lang="en-US" sz="20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as calculated in the cortex of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/+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lack) versus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/+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red) and data were normalized to +/+ expression (Cortex: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100.0 ± 8.4;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/+,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3.0 ± 6.4,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 = 4 mice per genotype, *p=0.033; Amygdala: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100.0 ± 4.2 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/+,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48.8 ± 12.0,</a:t>
            </a:r>
            <a:r>
              <a:rPr lang="en-US" sz="2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 = 3 mice per genotype, *p=0.019). </a:t>
            </a:r>
          </a:p>
        </p:txBody>
      </p:sp>
    </p:spTree>
    <p:extLst>
      <p:ext uri="{BB962C8B-B14F-4D97-AF65-F5344CB8AC3E}">
        <p14:creationId xmlns:p14="http://schemas.microsoft.com/office/powerpoint/2010/main" val="1556574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1245E4-DF70-393D-90B3-1A6264786D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359605B2-48A4-4932-21E9-C0AD0BE437D2}"/>
              </a:ext>
            </a:extLst>
          </p:cNvPr>
          <p:cNvSpPr txBox="1"/>
          <p:nvPr/>
        </p:nvSpPr>
        <p:spPr>
          <a:xfrm>
            <a:off x="241302" y="315011"/>
            <a:ext cx="11313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 Fig. 2 </a:t>
            </a:r>
          </a:p>
        </p:txBody>
      </p:sp>
      <p:sp>
        <p:nvSpPr>
          <p:cNvPr id="4" name="Isosceles Triangle 3">
            <a:extLst>
              <a:ext uri="{FF2B5EF4-FFF2-40B4-BE49-F238E27FC236}">
                <a16:creationId xmlns:a16="http://schemas.microsoft.com/office/drawing/2014/main" id="{95664043-5D9C-9F0E-A562-E1DAB6F5700A}"/>
              </a:ext>
            </a:extLst>
          </p:cNvPr>
          <p:cNvSpPr/>
          <p:nvPr/>
        </p:nvSpPr>
        <p:spPr>
          <a:xfrm rot="16200000">
            <a:off x="7005625" y="3154847"/>
            <a:ext cx="133004" cy="191193"/>
          </a:xfrm>
          <a:prstGeom prst="triangl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9E86B2-5847-0A7E-2495-F896C837B7B0}"/>
              </a:ext>
            </a:extLst>
          </p:cNvPr>
          <p:cNvSpPr/>
          <p:nvPr/>
        </p:nvSpPr>
        <p:spPr>
          <a:xfrm>
            <a:off x="7167724" y="3093099"/>
            <a:ext cx="159851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Mono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Isosceles Triangle 5">
            <a:extLst>
              <a:ext uri="{FF2B5EF4-FFF2-40B4-BE49-F238E27FC236}">
                <a16:creationId xmlns:a16="http://schemas.microsoft.com/office/drawing/2014/main" id="{3936D20F-E6F5-A2FD-7119-349A97166A3A}"/>
              </a:ext>
            </a:extLst>
          </p:cNvPr>
          <p:cNvSpPr/>
          <p:nvPr/>
        </p:nvSpPr>
        <p:spPr>
          <a:xfrm rot="16200000">
            <a:off x="7006130" y="2197861"/>
            <a:ext cx="131994" cy="191193"/>
          </a:xfrm>
          <a:prstGeom prst="triangl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11080EB-D308-2830-DA9C-22D872B08CA1}"/>
              </a:ext>
            </a:extLst>
          </p:cNvPr>
          <p:cNvSpPr/>
          <p:nvPr/>
        </p:nvSpPr>
        <p:spPr>
          <a:xfrm>
            <a:off x="7167724" y="2136618"/>
            <a:ext cx="130195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Di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2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" name="Isosceles Triangle 8">
            <a:extLst>
              <a:ext uri="{FF2B5EF4-FFF2-40B4-BE49-F238E27FC236}">
                <a16:creationId xmlns:a16="http://schemas.microsoft.com/office/drawing/2014/main" id="{4691CEC0-1735-A7EC-C8B2-5ABEB666360B}"/>
              </a:ext>
            </a:extLst>
          </p:cNvPr>
          <p:cNvSpPr/>
          <p:nvPr/>
        </p:nvSpPr>
        <p:spPr>
          <a:xfrm rot="16200000">
            <a:off x="7005625" y="3999293"/>
            <a:ext cx="133004" cy="191193"/>
          </a:xfrm>
          <a:prstGeom prst="triangl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969FF6E-9E85-DA98-3632-06672D8C738C}"/>
              </a:ext>
            </a:extLst>
          </p:cNvPr>
          <p:cNvSpPr/>
          <p:nvPr/>
        </p:nvSpPr>
        <p:spPr>
          <a:xfrm>
            <a:off x="7149684" y="3937545"/>
            <a:ext cx="87075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F0FD42-E5FC-4DBF-A58D-0A63EC82F18A}"/>
              </a:ext>
            </a:extLst>
          </p:cNvPr>
          <p:cNvSpPr txBox="1"/>
          <p:nvPr/>
        </p:nvSpPr>
        <p:spPr>
          <a:xfrm>
            <a:off x="4019393" y="1935066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60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6734F5-85F1-9A3D-D108-F9D7BD8CD241}"/>
              </a:ext>
            </a:extLst>
          </p:cNvPr>
          <p:cNvSpPr txBox="1"/>
          <p:nvPr/>
        </p:nvSpPr>
        <p:spPr>
          <a:xfrm>
            <a:off x="4019393" y="2636788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40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EC3AE48-B28D-1C8D-E293-729D8DF1A9BA}"/>
              </a:ext>
            </a:extLst>
          </p:cNvPr>
          <p:cNvSpPr txBox="1"/>
          <p:nvPr/>
        </p:nvSpPr>
        <p:spPr>
          <a:xfrm>
            <a:off x="4019393" y="3091175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89F2892-49BD-8551-FC07-F1A425B5AEBB}"/>
              </a:ext>
            </a:extLst>
          </p:cNvPr>
          <p:cNvSpPr txBox="1"/>
          <p:nvPr/>
        </p:nvSpPr>
        <p:spPr>
          <a:xfrm>
            <a:off x="4118779" y="3499338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289E33-B141-01A7-E166-7F84626536F7}"/>
              </a:ext>
            </a:extLst>
          </p:cNvPr>
          <p:cNvSpPr txBox="1"/>
          <p:nvPr/>
        </p:nvSpPr>
        <p:spPr>
          <a:xfrm>
            <a:off x="4118779" y="388260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3D452B6-6658-39E1-31D9-697F58C0AD18}"/>
              </a:ext>
            </a:extLst>
          </p:cNvPr>
          <p:cNvSpPr txBox="1"/>
          <p:nvPr/>
        </p:nvSpPr>
        <p:spPr>
          <a:xfrm>
            <a:off x="5719112" y="1459222"/>
            <a:ext cx="973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Grm7 K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EF99B8F-60FE-D8AE-20EC-F40A2AA5799E}"/>
              </a:ext>
            </a:extLst>
          </p:cNvPr>
          <p:cNvSpPr txBox="1"/>
          <p:nvPr/>
        </p:nvSpPr>
        <p:spPr>
          <a:xfrm>
            <a:off x="5533442" y="1724448"/>
            <a:ext cx="7136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BFE4ED2-54C9-3539-DDAF-79A806065C6F}"/>
              </a:ext>
            </a:extLst>
          </p:cNvPr>
          <p:cNvSpPr txBox="1"/>
          <p:nvPr/>
        </p:nvSpPr>
        <p:spPr>
          <a:xfrm>
            <a:off x="6282909" y="1724448"/>
            <a:ext cx="52610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algn="ctr"/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EF99B8F-60FE-D8AE-20EC-F40A2AA5799E}"/>
              </a:ext>
            </a:extLst>
          </p:cNvPr>
          <p:cNvSpPr txBox="1"/>
          <p:nvPr/>
        </p:nvSpPr>
        <p:spPr>
          <a:xfrm>
            <a:off x="4874979" y="1724448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03326" y="2018318"/>
            <a:ext cx="2012175" cy="358511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1BB0B9AF-58E5-B579-8FA0-8612EB72B112}"/>
              </a:ext>
            </a:extLst>
          </p:cNvPr>
          <p:cNvSpPr txBox="1"/>
          <p:nvPr/>
        </p:nvSpPr>
        <p:spPr>
          <a:xfrm>
            <a:off x="5320124" y="568851"/>
            <a:ext cx="11721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Alomon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A/B</a:t>
            </a:r>
          </a:p>
        </p:txBody>
      </p:sp>
    </p:spTree>
    <p:extLst>
      <p:ext uri="{BB962C8B-B14F-4D97-AF65-F5344CB8AC3E}">
        <p14:creationId xmlns:p14="http://schemas.microsoft.com/office/powerpoint/2010/main" val="12076754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76B1897-E44E-B389-6EDC-4A9ABA82E5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C351059-8FF2-84BD-57EF-2596E127114B}"/>
              </a:ext>
            </a:extLst>
          </p:cNvPr>
          <p:cNvSpPr txBox="1"/>
          <p:nvPr/>
        </p:nvSpPr>
        <p:spPr>
          <a:xfrm>
            <a:off x="241302" y="315011"/>
            <a:ext cx="1149349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 Fig. 2. </a:t>
            </a:r>
            <a:r>
              <a:rPr lang="en-US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</a:t>
            </a:r>
            <a:r>
              <a:rPr lang="en-US" sz="2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munoblot of mGlu</a:t>
            </a:r>
            <a:r>
              <a:rPr lang="en-US" sz="20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the hippocampus of </a:t>
            </a:r>
            <a:r>
              <a:rPr lang="en-US" sz="2000" b="1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m7 KO </a:t>
            </a:r>
            <a:r>
              <a:rPr lang="en-US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used as negative controls.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s representing the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al absence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he mGlu</a:t>
            </a:r>
            <a:r>
              <a:rPr lang="en-US" sz="20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mer (200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monomer (100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soforms in the hippocampus of </a:t>
            </a:r>
            <a:r>
              <a:rPr lang="en-US" sz="20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m7 KO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the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mone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tibody. Tubulin (50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as used as loading control. n = 2 mice per genotype.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illipore antibody was verified in Gogliotti et al., 2017, </a:t>
            </a:r>
            <a:r>
              <a:rPr lang="en-US" sz="20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ience Translational Medicine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sz="20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8454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365</Words>
  <Application>Microsoft Office PowerPoint</Application>
  <PresentationFormat>Widescreen</PresentationFormat>
  <Paragraphs>2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Times New Roman</vt:lpstr>
      <vt:lpstr>Office Theme</vt:lpstr>
      <vt:lpstr>Overexpression of mGlu7B in mice: implications for neurodevelopmental disorders Geanne A. Freitas*, Kelly Weiss*, Vaishnavi Bavadekar*, Sheryl Anne D. Vermudez, Nicole M. Fisher, Aditi Buch, Shalini Dogra, Zixiu Xiang, Rocco G. Gogliotti, Colleen M. Niswender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verexpression of mGlu7B in mice mimics abnormal behavioral phenotypes observed in Grm7 knockout mice: implications for neurodevelopmental disorders Geanne A. Freitas*, Kelly Weiss*, Vaishnavi Bavadekar*, Sheryl Anne D. Vermudez, Aditi Buch, Shalini Dogra, Zixiu Xiang, Rocco G. Gogliotti, Colleen M. Niswender</dc:title>
  <dc:creator>Freitas, Geanne</dc:creator>
  <cp:lastModifiedBy>Niswender, Colleen</cp:lastModifiedBy>
  <cp:revision>16</cp:revision>
  <dcterms:created xsi:type="dcterms:W3CDTF">2025-01-30T16:36:13Z</dcterms:created>
  <dcterms:modified xsi:type="dcterms:W3CDTF">2025-06-12T20:59:04Z</dcterms:modified>
</cp:coreProperties>
</file>